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5620"/>
    <p:restoredTop sz="94660"/>
  </p:normalViewPr>
  <p:slideViewPr>
    <p:cSldViewPr>
      <p:cViewPr>
        <p:scale>
          <a:sx n="150" d="100"/>
          <a:sy n="150" d="100"/>
        </p:scale>
        <p:origin x="-1208" y="155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__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計算!$C$12</c:f>
              <c:strCache>
                <c:ptCount val="1"/>
                <c:pt idx="0">
                  <c:v>Internal Medicine</c:v>
                </c:pt>
              </c:strCache>
            </c:strRef>
          </c:tx>
          <c:spPr>
            <a:ln w="15875">
              <a:solidFill>
                <a:schemeClr val="tx1"/>
              </a:solidFill>
              <a:prstDash val="sysDot"/>
            </a:ln>
          </c:spPr>
          <c:marker>
            <c:symbol val="none"/>
          </c:marker>
          <c:cat>
            <c:multiLvlStrRef>
              <c:f>計算!$D$10:$AA$11</c:f>
              <c:multiLvlStrCache>
                <c:ptCount val="24"/>
                <c:lvl>
                  <c:pt idx="0">
                    <c:v>Jan</c:v>
                  </c:pt>
                  <c:pt idx="1">
                    <c:v>Feb</c:v>
                  </c:pt>
                  <c:pt idx="2">
                    <c:v>Mar</c:v>
                  </c:pt>
                  <c:pt idx="3">
                    <c:v>Apr</c:v>
                  </c:pt>
                  <c:pt idx="4">
                    <c:v>May</c:v>
                  </c:pt>
                  <c:pt idx="5">
                    <c:v>Jun</c:v>
                  </c:pt>
                  <c:pt idx="6">
                    <c:v>Jul</c:v>
                  </c:pt>
                  <c:pt idx="7">
                    <c:v>Aug</c:v>
                  </c:pt>
                  <c:pt idx="8">
                    <c:v>Sep</c:v>
                  </c:pt>
                  <c:pt idx="9">
                    <c:v>Oct</c:v>
                  </c:pt>
                  <c:pt idx="10">
                    <c:v>Nov</c:v>
                  </c:pt>
                  <c:pt idx="11">
                    <c:v>Dec</c:v>
                  </c:pt>
                  <c:pt idx="12">
                    <c:v>Jan</c:v>
                  </c:pt>
                  <c:pt idx="13">
                    <c:v>Feb</c:v>
                  </c:pt>
                  <c:pt idx="14">
                    <c:v>Mar</c:v>
                  </c:pt>
                  <c:pt idx="15">
                    <c:v>Apr</c:v>
                  </c:pt>
                  <c:pt idx="16">
                    <c:v>May</c:v>
                  </c:pt>
                  <c:pt idx="17">
                    <c:v>Jun</c:v>
                  </c:pt>
                  <c:pt idx="18">
                    <c:v>Jul</c:v>
                  </c:pt>
                  <c:pt idx="19">
                    <c:v>Aug</c:v>
                  </c:pt>
                  <c:pt idx="20">
                    <c:v>Sep</c:v>
                  </c:pt>
                  <c:pt idx="21">
                    <c:v>Oct</c:v>
                  </c:pt>
                  <c:pt idx="22">
                    <c:v>Nov</c:v>
                  </c:pt>
                  <c:pt idx="23">
                    <c:v>Dec</c:v>
                  </c:pt>
                </c:lvl>
                <c:lvl>
                  <c:pt idx="0">
                    <c:v>2020</c:v>
                  </c:pt>
                  <c:pt idx="12">
                    <c:v>2021</c:v>
                  </c:pt>
                </c:lvl>
              </c:multiLvlStrCache>
            </c:multiLvlStrRef>
          </c:cat>
          <c:val>
            <c:numRef>
              <c:f>計算!$D$12:$AA$12</c:f>
              <c:numCache>
                <c:formatCode>0.0_ </c:formatCode>
                <c:ptCount val="24"/>
                <c:pt idx="0">
                  <c:v>-14.785577638774484</c:v>
                </c:pt>
                <c:pt idx="1">
                  <c:v>-1.4304290238624204</c:v>
                </c:pt>
                <c:pt idx="2">
                  <c:v>-12.974542021267949</c:v>
                </c:pt>
                <c:pt idx="3">
                  <c:v>-20.623490814636607</c:v>
                </c:pt>
                <c:pt idx="4">
                  <c:v>-24.809209366272654</c:v>
                </c:pt>
                <c:pt idx="5">
                  <c:v>-15.912579990423964</c:v>
                </c:pt>
                <c:pt idx="6">
                  <c:v>-13.857548588101306</c:v>
                </c:pt>
                <c:pt idx="7">
                  <c:v>-9.5091308052103063</c:v>
                </c:pt>
                <c:pt idx="8">
                  <c:v>-10.358211473148739</c:v>
                </c:pt>
                <c:pt idx="9">
                  <c:v>-6.7532123627647449</c:v>
                </c:pt>
                <c:pt idx="10">
                  <c:v>-16.506740001113194</c:v>
                </c:pt>
                <c:pt idx="11">
                  <c:v>-19.56979580598334</c:v>
                </c:pt>
                <c:pt idx="12">
                  <c:v>-34.292112087569492</c:v>
                </c:pt>
                <c:pt idx="13">
                  <c:v>-18.284728791260335</c:v>
                </c:pt>
                <c:pt idx="14">
                  <c:v>-10.842894113844503</c:v>
                </c:pt>
                <c:pt idx="15">
                  <c:v>-8.7899285860503529</c:v>
                </c:pt>
                <c:pt idx="16">
                  <c:v>-8.9458824784848812</c:v>
                </c:pt>
                <c:pt idx="17">
                  <c:v>-5.9765059912080121</c:v>
                </c:pt>
                <c:pt idx="18">
                  <c:v>-6.1906020791026384</c:v>
                </c:pt>
                <c:pt idx="19">
                  <c:v>-8.4435484038067457E-2</c:v>
                </c:pt>
                <c:pt idx="20">
                  <c:v>-3.562213579130022</c:v>
                </c:pt>
                <c:pt idx="21">
                  <c:v>-6.1143835016407007</c:v>
                </c:pt>
                <c:pt idx="22">
                  <c:v>-10.819481708630271</c:v>
                </c:pt>
                <c:pt idx="23">
                  <c:v>-15.49941109333978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計算!$C$13</c:f>
              <c:strCache>
                <c:ptCount val="1"/>
                <c:pt idx="0">
                  <c:v>Pediatrics</c:v>
                </c:pt>
              </c:strCache>
            </c:strRef>
          </c:tx>
          <c:spPr>
            <a:ln w="15875">
              <a:solidFill>
                <a:schemeClr val="tx1"/>
              </a:solidFill>
              <a:prstDash val="dash"/>
            </a:ln>
          </c:spPr>
          <c:marker>
            <c:symbol val="none"/>
          </c:marker>
          <c:cat>
            <c:multiLvlStrRef>
              <c:f>計算!$D$10:$AA$11</c:f>
              <c:multiLvlStrCache>
                <c:ptCount val="24"/>
                <c:lvl>
                  <c:pt idx="0">
                    <c:v>Jan</c:v>
                  </c:pt>
                  <c:pt idx="1">
                    <c:v>Feb</c:v>
                  </c:pt>
                  <c:pt idx="2">
                    <c:v>Mar</c:v>
                  </c:pt>
                  <c:pt idx="3">
                    <c:v>Apr</c:v>
                  </c:pt>
                  <c:pt idx="4">
                    <c:v>May</c:v>
                  </c:pt>
                  <c:pt idx="5">
                    <c:v>Jun</c:v>
                  </c:pt>
                  <c:pt idx="6">
                    <c:v>Jul</c:v>
                  </c:pt>
                  <c:pt idx="7">
                    <c:v>Aug</c:v>
                  </c:pt>
                  <c:pt idx="8">
                    <c:v>Sep</c:v>
                  </c:pt>
                  <c:pt idx="9">
                    <c:v>Oct</c:v>
                  </c:pt>
                  <c:pt idx="10">
                    <c:v>Nov</c:v>
                  </c:pt>
                  <c:pt idx="11">
                    <c:v>Dec</c:v>
                  </c:pt>
                  <c:pt idx="12">
                    <c:v>Jan</c:v>
                  </c:pt>
                  <c:pt idx="13">
                    <c:v>Feb</c:v>
                  </c:pt>
                  <c:pt idx="14">
                    <c:v>Mar</c:v>
                  </c:pt>
                  <c:pt idx="15">
                    <c:v>Apr</c:v>
                  </c:pt>
                  <c:pt idx="16">
                    <c:v>May</c:v>
                  </c:pt>
                  <c:pt idx="17">
                    <c:v>Jun</c:v>
                  </c:pt>
                  <c:pt idx="18">
                    <c:v>Jul</c:v>
                  </c:pt>
                  <c:pt idx="19">
                    <c:v>Aug</c:v>
                  </c:pt>
                  <c:pt idx="20">
                    <c:v>Sep</c:v>
                  </c:pt>
                  <c:pt idx="21">
                    <c:v>Oct</c:v>
                  </c:pt>
                  <c:pt idx="22">
                    <c:v>Nov</c:v>
                  </c:pt>
                  <c:pt idx="23">
                    <c:v>Dec</c:v>
                  </c:pt>
                </c:lvl>
                <c:lvl>
                  <c:pt idx="0">
                    <c:v>2020</c:v>
                  </c:pt>
                  <c:pt idx="12">
                    <c:v>2021</c:v>
                  </c:pt>
                </c:lvl>
              </c:multiLvlStrCache>
            </c:multiLvlStrRef>
          </c:cat>
          <c:val>
            <c:numRef>
              <c:f>計算!$D$13:$AA$13</c:f>
              <c:numCache>
                <c:formatCode>0.0_ </c:formatCode>
                <c:ptCount val="24"/>
                <c:pt idx="0">
                  <c:v>-16.231320567033393</c:v>
                </c:pt>
                <c:pt idx="1">
                  <c:v>1.4718004280435313</c:v>
                </c:pt>
                <c:pt idx="2">
                  <c:v>-22.616978285372451</c:v>
                </c:pt>
                <c:pt idx="3">
                  <c:v>-38.171564395279091</c:v>
                </c:pt>
                <c:pt idx="4">
                  <c:v>-46.150946534197914</c:v>
                </c:pt>
                <c:pt idx="5">
                  <c:v>-33.63192051414579</c:v>
                </c:pt>
                <c:pt idx="6">
                  <c:v>-28.930956434638837</c:v>
                </c:pt>
                <c:pt idx="7">
                  <c:v>-26.622062733911804</c:v>
                </c:pt>
                <c:pt idx="8">
                  <c:v>-29.928587763359076</c:v>
                </c:pt>
                <c:pt idx="9">
                  <c:v>-11.773043196885054</c:v>
                </c:pt>
                <c:pt idx="10">
                  <c:v>-22.336282678570441</c:v>
                </c:pt>
                <c:pt idx="11">
                  <c:v>-29.117807861957179</c:v>
                </c:pt>
                <c:pt idx="12">
                  <c:v>-45.712770338975304</c:v>
                </c:pt>
                <c:pt idx="13">
                  <c:v>-25.084566652683556</c:v>
                </c:pt>
                <c:pt idx="14">
                  <c:v>-15.834327941124807</c:v>
                </c:pt>
                <c:pt idx="15">
                  <c:v>-13.35526580872186</c:v>
                </c:pt>
                <c:pt idx="16">
                  <c:v>-12.531462916161287</c:v>
                </c:pt>
                <c:pt idx="17">
                  <c:v>-10.44388367794129</c:v>
                </c:pt>
                <c:pt idx="18">
                  <c:v>-8.8600404269129243</c:v>
                </c:pt>
                <c:pt idx="19">
                  <c:v>-7.0659323284071567</c:v>
                </c:pt>
                <c:pt idx="20">
                  <c:v>-21.006201579612071</c:v>
                </c:pt>
                <c:pt idx="21">
                  <c:v>-7.8593032553437858</c:v>
                </c:pt>
                <c:pt idx="22">
                  <c:v>-5.566051838865242</c:v>
                </c:pt>
                <c:pt idx="23">
                  <c:v>-17.386182975488985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計算!$C$14</c:f>
              <c:strCache>
                <c:ptCount val="1"/>
                <c:pt idx="0">
                  <c:v>Dermatlogy</c:v>
                </c:pt>
              </c:strCache>
            </c:strRef>
          </c:tx>
          <c:spPr>
            <a:ln w="15875">
              <a:solidFill>
                <a:schemeClr val="tx1"/>
              </a:solidFill>
            </a:ln>
          </c:spPr>
          <c:marker>
            <c:symbol val="none"/>
          </c:marker>
          <c:cat>
            <c:multiLvlStrRef>
              <c:f>計算!$D$10:$AA$11</c:f>
              <c:multiLvlStrCache>
                <c:ptCount val="24"/>
                <c:lvl>
                  <c:pt idx="0">
                    <c:v>Jan</c:v>
                  </c:pt>
                  <c:pt idx="1">
                    <c:v>Feb</c:v>
                  </c:pt>
                  <c:pt idx="2">
                    <c:v>Mar</c:v>
                  </c:pt>
                  <c:pt idx="3">
                    <c:v>Apr</c:v>
                  </c:pt>
                  <c:pt idx="4">
                    <c:v>May</c:v>
                  </c:pt>
                  <c:pt idx="5">
                    <c:v>Jun</c:v>
                  </c:pt>
                  <c:pt idx="6">
                    <c:v>Jul</c:v>
                  </c:pt>
                  <c:pt idx="7">
                    <c:v>Aug</c:v>
                  </c:pt>
                  <c:pt idx="8">
                    <c:v>Sep</c:v>
                  </c:pt>
                  <c:pt idx="9">
                    <c:v>Oct</c:v>
                  </c:pt>
                  <c:pt idx="10">
                    <c:v>Nov</c:v>
                  </c:pt>
                  <c:pt idx="11">
                    <c:v>Dec</c:v>
                  </c:pt>
                  <c:pt idx="12">
                    <c:v>Jan</c:v>
                  </c:pt>
                  <c:pt idx="13">
                    <c:v>Feb</c:v>
                  </c:pt>
                  <c:pt idx="14">
                    <c:v>Mar</c:v>
                  </c:pt>
                  <c:pt idx="15">
                    <c:v>Apr</c:v>
                  </c:pt>
                  <c:pt idx="16">
                    <c:v>May</c:v>
                  </c:pt>
                  <c:pt idx="17">
                    <c:v>Jun</c:v>
                  </c:pt>
                  <c:pt idx="18">
                    <c:v>Jul</c:v>
                  </c:pt>
                  <c:pt idx="19">
                    <c:v>Aug</c:v>
                  </c:pt>
                  <c:pt idx="20">
                    <c:v>Sep</c:v>
                  </c:pt>
                  <c:pt idx="21">
                    <c:v>Oct</c:v>
                  </c:pt>
                  <c:pt idx="22">
                    <c:v>Nov</c:v>
                  </c:pt>
                  <c:pt idx="23">
                    <c:v>Dec</c:v>
                  </c:pt>
                </c:lvl>
                <c:lvl>
                  <c:pt idx="0">
                    <c:v>2020</c:v>
                  </c:pt>
                  <c:pt idx="12">
                    <c:v>2021</c:v>
                  </c:pt>
                </c:lvl>
              </c:multiLvlStrCache>
            </c:multiLvlStrRef>
          </c:cat>
          <c:val>
            <c:numRef>
              <c:f>計算!$D$14:$AA$14</c:f>
              <c:numCache>
                <c:formatCode>0.0_ </c:formatCode>
                <c:ptCount val="24"/>
                <c:pt idx="0">
                  <c:v>0.70416445101116687</c:v>
                </c:pt>
                <c:pt idx="1">
                  <c:v>5.6995102420710113</c:v>
                </c:pt>
                <c:pt idx="2">
                  <c:v>0.24173524829080276</c:v>
                </c:pt>
                <c:pt idx="3">
                  <c:v>-11.032704926570149</c:v>
                </c:pt>
                <c:pt idx="4">
                  <c:v>-2.6380346712215874</c:v>
                </c:pt>
                <c:pt idx="5">
                  <c:v>6.7079185608754424</c:v>
                </c:pt>
                <c:pt idx="6">
                  <c:v>-3.8982853923627205</c:v>
                </c:pt>
                <c:pt idx="7">
                  <c:v>5.361203533197104</c:v>
                </c:pt>
                <c:pt idx="8">
                  <c:v>2.286280446366026</c:v>
                </c:pt>
                <c:pt idx="9">
                  <c:v>10.442883116688034</c:v>
                </c:pt>
                <c:pt idx="10">
                  <c:v>-1.0942120030117892</c:v>
                </c:pt>
                <c:pt idx="11">
                  <c:v>6.6712431614724386</c:v>
                </c:pt>
                <c:pt idx="12">
                  <c:v>1.133648953075943</c:v>
                </c:pt>
                <c:pt idx="13">
                  <c:v>3.2105983301148777</c:v>
                </c:pt>
                <c:pt idx="14">
                  <c:v>1.9046525608794951</c:v>
                </c:pt>
                <c:pt idx="15">
                  <c:v>3.8197206851236682</c:v>
                </c:pt>
                <c:pt idx="16">
                  <c:v>-1.5906388180693547</c:v>
                </c:pt>
                <c:pt idx="17">
                  <c:v>3.271772984520581</c:v>
                </c:pt>
                <c:pt idx="18">
                  <c:v>-2.0459635794716635</c:v>
                </c:pt>
                <c:pt idx="19">
                  <c:v>-3.3874043976506893</c:v>
                </c:pt>
                <c:pt idx="20">
                  <c:v>1.4575846070965353</c:v>
                </c:pt>
                <c:pt idx="21">
                  <c:v>10.335653370601833</c:v>
                </c:pt>
                <c:pt idx="22">
                  <c:v>0.32452000666404879</c:v>
                </c:pt>
                <c:pt idx="23">
                  <c:v>2.575970046794892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0958592"/>
        <c:axId val="119427840"/>
      </c:lineChart>
      <c:catAx>
        <c:axId val="190958592"/>
        <c:scaling>
          <c:orientation val="minMax"/>
        </c:scaling>
        <c:delete val="0"/>
        <c:axPos val="b"/>
        <c:majorTickMark val="out"/>
        <c:minorTickMark val="none"/>
        <c:tickLblPos val="low"/>
        <c:spPr>
          <a:ln>
            <a:solidFill>
              <a:schemeClr val="bg1">
                <a:lumMod val="85000"/>
              </a:schemeClr>
            </a:solidFill>
          </a:ln>
        </c:spPr>
        <c:crossAx val="119427840"/>
        <c:crosses val="autoZero"/>
        <c:auto val="1"/>
        <c:lblAlgn val="ctr"/>
        <c:lblOffset val="100"/>
        <c:noMultiLvlLbl val="0"/>
      </c:catAx>
      <c:valAx>
        <c:axId val="119427840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0_ " sourceLinked="0"/>
        <c:majorTickMark val="out"/>
        <c:minorTickMark val="none"/>
        <c:tickLblPos val="nextTo"/>
        <c:crossAx val="19095859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7395684243565599"/>
          <c:y val="0.61072727272727267"/>
          <c:w val="0.20332642812303831"/>
          <c:h val="0.13621938131313133"/>
        </c:manualLayout>
      </c:layout>
      <c:overlay val="1"/>
    </c:legend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 Narrow" pitchFamily="34" charset="0"/>
        </a:defRPr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397398-78E9-4292-A63B-134A0E1562A0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006600" y="746125"/>
            <a:ext cx="27940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21225"/>
            <a:ext cx="5445125" cy="44719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9FB13B-18E4-4199-A5A6-D030235CC6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13586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093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18654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26982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9782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9538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0073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5112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728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42004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55862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63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89AB31-6F32-42D7-8571-3D48FA77560E}" type="datetimeFigureOut">
              <a:rPr kumimoji="1" lang="ja-JP" altLang="en-US" smtClean="0"/>
              <a:t>2023/4/2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31D743-8A98-43BE-8739-52F9DFD218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4615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/>
          <p:cNvSpPr txBox="1"/>
          <p:nvPr/>
        </p:nvSpPr>
        <p:spPr>
          <a:xfrm rot="16200000">
            <a:off x="-824988" y="3209365"/>
            <a:ext cx="2160242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Arial Narrow" pitchFamily="34" charset="0"/>
              </a:rPr>
              <a:t>Compared </a:t>
            </a:r>
            <a:r>
              <a:rPr lang="en-US" altLang="ja-JP" sz="1200" dirty="0">
                <a:latin typeface="Arial Narrow" pitchFamily="34" charset="0"/>
              </a:rPr>
              <a:t>to same month in </a:t>
            </a:r>
            <a:r>
              <a:rPr lang="en-US" altLang="ja-JP" sz="1200" dirty="0" smtClean="0">
                <a:latin typeface="Arial Narrow" pitchFamily="34" charset="0"/>
              </a:rPr>
              <a:t>2019</a:t>
            </a:r>
            <a:r>
              <a:rPr lang="ja-JP" altLang="en-US" sz="1200" dirty="0">
                <a:latin typeface="Arial Narrow" pitchFamily="34" charset="0"/>
              </a:rPr>
              <a:t>　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189294" y="5087089"/>
            <a:ext cx="8971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 Narrow" pitchFamily="34" charset="0"/>
              </a:rPr>
              <a:t>Month / Year</a:t>
            </a:r>
            <a:endParaRPr kumimoji="1" lang="ja-JP" altLang="en-US" sz="1200" dirty="0">
              <a:latin typeface="Arial Narrow" pitchFamily="34" charset="0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5936790" y="8670598"/>
            <a:ext cx="74732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2 </a:t>
            </a:r>
            <a:r>
              <a:rPr lang="en-US" altLang="ja-JP" sz="14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Fig. </a:t>
            </a:r>
            <a:endParaRPr lang="ja-JP" altLang="en-US" dirty="0"/>
          </a:p>
        </p:txBody>
      </p:sp>
      <p:sp>
        <p:nvSpPr>
          <p:cNvPr id="7" name="正方形/長方形 6"/>
          <p:cNvSpPr/>
          <p:nvPr/>
        </p:nvSpPr>
        <p:spPr>
          <a:xfrm>
            <a:off x="4383004" y="2134761"/>
            <a:ext cx="1431586" cy="2495702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正方形/長方形 7"/>
          <p:cNvSpPr/>
          <p:nvPr/>
        </p:nvSpPr>
        <p:spPr>
          <a:xfrm>
            <a:off x="1422103" y="2134761"/>
            <a:ext cx="432048" cy="251240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正方形/長方形 9"/>
          <p:cNvSpPr/>
          <p:nvPr/>
        </p:nvSpPr>
        <p:spPr>
          <a:xfrm>
            <a:off x="3637847" y="2134761"/>
            <a:ext cx="664576" cy="249570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正方形/長方形 12"/>
          <p:cNvSpPr/>
          <p:nvPr/>
        </p:nvSpPr>
        <p:spPr>
          <a:xfrm>
            <a:off x="5087935" y="2134760"/>
            <a:ext cx="726655" cy="251240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正方形/長方形 13"/>
          <p:cNvSpPr/>
          <p:nvPr/>
        </p:nvSpPr>
        <p:spPr>
          <a:xfrm>
            <a:off x="4489396" y="2134761"/>
            <a:ext cx="533107" cy="251240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6589592"/>
              </p:ext>
            </p:extLst>
          </p:nvPr>
        </p:nvGraphicFramePr>
        <p:xfrm>
          <a:off x="297360" y="1990745"/>
          <a:ext cx="6372000" cy="316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5598567" y="2103745"/>
            <a:ext cx="9380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>
                <a:latin typeface="Arial Narrow" pitchFamily="34" charset="0"/>
              </a:rPr>
              <a:t>Outpatients</a:t>
            </a:r>
            <a:endParaRPr kumimoji="1" lang="ja-JP" altLang="en-US" sz="1400" dirty="0">
              <a:latin typeface="Arial Narrow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743201" y="2233125"/>
            <a:ext cx="210523" cy="72008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946490" y="2130685"/>
            <a:ext cx="16017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Arial Narrow" pitchFamily="34" charset="0"/>
              </a:rPr>
              <a:t>Declaration of state of emergency</a:t>
            </a:r>
            <a:endParaRPr kumimoji="1" lang="ja-JP" altLang="en-US" sz="900" dirty="0">
              <a:latin typeface="Arial Narrow" pitchFamily="34" charset="0"/>
            </a:endParaRPr>
          </a:p>
        </p:txBody>
      </p:sp>
      <p:sp>
        <p:nvSpPr>
          <p:cNvPr id="16" name="正方形/長方形 15"/>
          <p:cNvSpPr/>
          <p:nvPr/>
        </p:nvSpPr>
        <p:spPr>
          <a:xfrm>
            <a:off x="743201" y="2361517"/>
            <a:ext cx="210523" cy="72008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40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946490" y="2274701"/>
            <a:ext cx="13805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 Narrow" pitchFamily="34" charset="0"/>
              </a:rPr>
              <a:t>Quasi-emergency measures</a:t>
            </a:r>
            <a:endParaRPr kumimoji="1" lang="ja-JP" altLang="en-US" sz="900" dirty="0">
              <a:latin typeface="Arial Narrow" pitchFamily="34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96440" y="2103983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 Narrow" pitchFamily="34" charset="0"/>
              </a:rPr>
              <a:t>(%)</a:t>
            </a:r>
            <a:endParaRPr kumimoji="1" lang="ja-JP" altLang="en-US" sz="1200" dirty="0">
              <a:latin typeface="Arial Narrow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6462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322</TotalTime>
  <Words>21</Words>
  <Application>Microsoft Office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npopo</dc:creator>
  <cp:lastModifiedBy>kenpopo</cp:lastModifiedBy>
  <cp:revision>133</cp:revision>
  <cp:lastPrinted>2023-03-22T02:38:43Z</cp:lastPrinted>
  <dcterms:created xsi:type="dcterms:W3CDTF">2022-12-14T01:53:37Z</dcterms:created>
  <dcterms:modified xsi:type="dcterms:W3CDTF">2023-04-25T00:28:55Z</dcterms:modified>
</cp:coreProperties>
</file>